
<file path=[Content_Types].xml><?xml version="1.0" encoding="utf-8"?>
<Types xmlns="http://schemas.openxmlformats.org/package/2006/content-types">
  <Default Extension="avi" ContentType="video/x-msvideo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368" r:id="rId2"/>
    <p:sldId id="365" r:id="rId3"/>
    <p:sldId id="367" r:id="rId4"/>
    <p:sldId id="369" r:id="rId5"/>
    <p:sldId id="370" r:id="rId6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117F1"/>
    <a:srgbClr val="CC66FF"/>
    <a:srgbClr val="AFAB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211" autoAdjust="0"/>
    <p:restoredTop sz="94660"/>
  </p:normalViewPr>
  <p:slideViewPr>
    <p:cSldViewPr snapToGrid="0">
      <p:cViewPr varScale="1">
        <p:scale>
          <a:sx n="74" d="100"/>
          <a:sy n="74" d="100"/>
        </p:scale>
        <p:origin x="282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855502-0883-42D5-8CD6-7C01DA443F8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C6FD8B-5BCE-424D-B567-6A5FC319E7B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3626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3112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8959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832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0200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44388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7023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5563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019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7022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1939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1652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538018-5CBA-4634-AEF5-6CB44EB78324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6084DD-04A8-4E9B-BFE1-64F52904AB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7696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13" Type="http://schemas.openxmlformats.org/officeDocument/2006/relationships/image" Target="../media/image23.png"/><Relationship Id="rId18" Type="http://schemas.openxmlformats.org/officeDocument/2006/relationships/image" Target="../media/image2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12" Type="http://schemas.openxmlformats.org/officeDocument/2006/relationships/image" Target="../media/image22.png"/><Relationship Id="rId17" Type="http://schemas.openxmlformats.org/officeDocument/2006/relationships/image" Target="../media/image27.png"/><Relationship Id="rId2" Type="http://schemas.openxmlformats.org/officeDocument/2006/relationships/image" Target="../media/image12.png"/><Relationship Id="rId16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5" Type="http://schemas.openxmlformats.org/officeDocument/2006/relationships/image" Target="../media/image25.png"/><Relationship Id="rId10" Type="http://schemas.openxmlformats.org/officeDocument/2006/relationships/image" Target="../media/image20.png"/><Relationship Id="rId19" Type="http://schemas.openxmlformats.org/officeDocument/2006/relationships/image" Target="../media/image29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Relationship Id="rId14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3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4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2368" y="3343701"/>
            <a:ext cx="1800000" cy="180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6849" y="3343701"/>
            <a:ext cx="1800000" cy="1800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6288" y="3343701"/>
            <a:ext cx="1800000" cy="1800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142368" y="3352138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oB</a:t>
            </a:r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972487" y="3341610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-HDEL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796968" y="3339519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831839" y="1408731"/>
            <a:ext cx="329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850717" y="3299503"/>
            <a:ext cx="4292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161418" y="5227915"/>
            <a:ext cx="542487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Labelling controls for mitochondria (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Rhodamine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B in the red channel) (A) and co-expression of PmoB-GFP with the ER marker RFP-HDEL (B). Scale bars = 5 μm.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9758" y="1524980"/>
            <a:ext cx="1800000" cy="18000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64328" y="1523064"/>
            <a:ext cx="1800000" cy="18000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7443" y="1523064"/>
            <a:ext cx="1800000" cy="1800000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1142368" y="1552138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een channel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939758" y="1558569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 channel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796968" y="1552137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</p:spTree>
    <p:extLst>
      <p:ext uri="{BB962C8B-B14F-4D97-AF65-F5344CB8AC3E}">
        <p14:creationId xmlns:p14="http://schemas.microsoft.com/office/powerpoint/2010/main" val="31255644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96214" y="1094704"/>
            <a:ext cx="6684135" cy="53318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8118" y="1511666"/>
            <a:ext cx="1800000" cy="180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3109" y="3330716"/>
            <a:ext cx="1800000" cy="180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8118" y="3330716"/>
            <a:ext cx="1800000" cy="180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2652" y="3330716"/>
            <a:ext cx="1800000" cy="1800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2652" y="1511666"/>
            <a:ext cx="1800000" cy="1800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714997" y="5276850"/>
            <a:ext cx="5876766" cy="8891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Labelling of ER and faint mitochondria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H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GFP. (A, B) Inset of cells expressing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H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GFP. (C-E) Co-localization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H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GFP with rhodamine B-labelled mitochondria. Scale bars = 2 μm.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658118" y="1511666"/>
            <a:ext cx="390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458118" y="1502141"/>
            <a:ext cx="390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43652" y="3349766"/>
            <a:ext cx="390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567643" y="3344929"/>
            <a:ext cx="390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382652" y="3340241"/>
            <a:ext cx="3905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3399797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618897" y="9561602"/>
            <a:ext cx="673704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Labelling controls for signal peptide mutants.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GFP,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H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GFP and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∆H-GF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re co-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exoressed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with the ER marker RFP-HDEL (A, C, E) and together with rhodamine B hexyl ester-labelled mitochondria (B, D, F). Scale bars = 5 μm.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3996" y="5221098"/>
            <a:ext cx="1440000" cy="144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6901" y="5221098"/>
            <a:ext cx="1440000" cy="144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0686" y="5222503"/>
            <a:ext cx="1440000" cy="144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4459" y="6682872"/>
            <a:ext cx="1440000" cy="1440000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1404953" y="785453"/>
            <a:ext cx="329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3756" y="6682872"/>
            <a:ext cx="1440000" cy="1440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9345" y="6682872"/>
            <a:ext cx="1440000" cy="1440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5275" y="8154171"/>
            <a:ext cx="1440000" cy="1440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5645" y="8161255"/>
            <a:ext cx="1440000" cy="1440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5460" y="8154171"/>
            <a:ext cx="1440000" cy="14400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6339" y="816752"/>
            <a:ext cx="1440000" cy="144000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3696" y="816752"/>
            <a:ext cx="1440000" cy="144000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4780" y="816752"/>
            <a:ext cx="1440000" cy="1440000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3996" y="2282263"/>
            <a:ext cx="1440000" cy="1440000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1589" y="2278996"/>
            <a:ext cx="1440000" cy="1440000"/>
          </a:xfrm>
          <a:prstGeom prst="rect">
            <a:avLst/>
          </a:prstGeom>
        </p:spPr>
      </p:pic>
      <p:pic>
        <p:nvPicPr>
          <p:cNvPr id="34" name="Picture 33"/>
          <p:cNvPicPr>
            <a:picLocks noChangeAspect="1"/>
          </p:cNvPicPr>
          <p:nvPr/>
        </p:nvPicPr>
        <p:blipFill>
          <a:blip r:embed="rId1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2505" y="2279037"/>
            <a:ext cx="1440000" cy="1440000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1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3996" y="3749928"/>
            <a:ext cx="1440000" cy="1440000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1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3221" y="3754625"/>
            <a:ext cx="1440000" cy="1440000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>
          <a:blip r:embed="rId1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9798" y="3744583"/>
            <a:ext cx="1440000" cy="1440000"/>
          </a:xfrm>
          <a:prstGeom prst="rect">
            <a:avLst/>
          </a:prstGeom>
        </p:spPr>
      </p:pic>
      <p:sp>
        <p:nvSpPr>
          <p:cNvPr id="38" name="TextBox 37"/>
          <p:cNvSpPr txBox="1"/>
          <p:nvPr/>
        </p:nvSpPr>
        <p:spPr>
          <a:xfrm>
            <a:off x="1392366" y="2287922"/>
            <a:ext cx="329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380991" y="3736858"/>
            <a:ext cx="329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369616" y="5254034"/>
            <a:ext cx="329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1385536" y="6730270"/>
            <a:ext cx="329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1387808" y="8138264"/>
            <a:ext cx="329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683996" y="828470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135864" y="828470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-HDEL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641589" y="842475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682696" y="2330939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H</a:t>
            </a:r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3134564" y="2330939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-HDEL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4640289" y="2344944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676103" y="3778518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∆H-GFP</a:t>
            </a:r>
            <a:endParaRPr lang="en-GB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127971" y="3778518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-HDEL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4633696" y="3792523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689308" y="5254147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S</a:t>
            </a:r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141176" y="5254147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odamine</a:t>
            </a:r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4646901" y="5268152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1676103" y="6700921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H</a:t>
            </a:r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127971" y="6700921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odamine</a:t>
            </a:r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4633696" y="6714926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676103" y="8149546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∆H-GFP</a:t>
            </a:r>
            <a:endParaRPr lang="en-GB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127971" y="8149546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hodamine</a:t>
            </a:r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4633696" y="8163551"/>
            <a:ext cx="13108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</a:p>
        </p:txBody>
      </p:sp>
    </p:spTree>
    <p:extLst>
      <p:ext uri="{BB962C8B-B14F-4D97-AF65-F5344CB8AC3E}">
        <p14:creationId xmlns:p14="http://schemas.microsoft.com/office/powerpoint/2010/main" val="10616818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Supplementary Video S1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687202" y="2109157"/>
            <a:ext cx="4074325" cy="407432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687202" y="6268144"/>
            <a:ext cx="4818951" cy="6121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1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ovie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GFP.</a:t>
            </a:r>
          </a:p>
          <a:p>
            <a:pPr algn="just">
              <a:lnSpc>
                <a:spcPct val="150000"/>
              </a:lnSpc>
            </a:pP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GFP also showed a faint labelling of the ER. </a:t>
            </a:r>
          </a:p>
        </p:txBody>
      </p:sp>
    </p:spTree>
    <p:extLst>
      <p:ext uri="{BB962C8B-B14F-4D97-AF65-F5344CB8AC3E}">
        <p14:creationId xmlns:p14="http://schemas.microsoft.com/office/powerpoint/2010/main" val="40049367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Supplementary Video S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946148" y="2419519"/>
            <a:ext cx="3869159" cy="386915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946148" y="6288678"/>
            <a:ext cx="4818951" cy="6121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S2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ovie of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GFP.</a:t>
            </a:r>
          </a:p>
          <a:p>
            <a:pPr algn="just">
              <a:lnSpc>
                <a:spcPct val="150000"/>
              </a:lnSpc>
            </a:pP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s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GFP also showed a faint labelling of the ER. </a:t>
            </a:r>
          </a:p>
        </p:txBody>
      </p:sp>
    </p:spTree>
    <p:extLst>
      <p:ext uri="{BB962C8B-B14F-4D97-AF65-F5344CB8AC3E}">
        <p14:creationId xmlns:p14="http://schemas.microsoft.com/office/powerpoint/2010/main" val="16417408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22</Words>
  <Application>Microsoft Office PowerPoint</Application>
  <PresentationFormat>Custom</PresentationFormat>
  <Paragraphs>44</Paragraphs>
  <Slides>5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tiana rossi</dc:creator>
  <cp:lastModifiedBy>Tillie Wang</cp:lastModifiedBy>
  <cp:revision>572</cp:revision>
  <dcterms:created xsi:type="dcterms:W3CDTF">2021-12-15T08:47:01Z</dcterms:created>
  <dcterms:modified xsi:type="dcterms:W3CDTF">2023-01-31T02:54:37Z</dcterms:modified>
</cp:coreProperties>
</file>